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84" y="34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FAFFE3-062D-488E-8996-93B9EA592A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7036C8F-57ED-47B6-B317-43D88B3418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D87C05B-63BA-4842-BA03-4E3B3DD9F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AF5201-2985-4ED8-9D35-CCEF9A869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8D15F7-4107-4E18-B1C7-CFBAA96F2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9532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B4F413-4EB8-4AFC-BC4E-6FAE021FFB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9F28CFC-0998-4745-9A15-F86BF4F5D7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944A04F-1247-4E4F-BCB5-F2ADF4182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920F151-A317-4541-AF3B-C92CCBF1A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9D4B291-B8F8-49E7-B288-BB37236FC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8248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E1C178B-8A87-4D53-865C-41C5CFCA4B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61F07B0-4715-4784-A85F-C4C46BC328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ABA0998-1811-457C-9B88-E0F64BECB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02DF88-B5E4-45AD-94DB-52506CB1C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614A77-35B6-45C9-AC7E-EB9A6A5CE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7877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2EE513C-10C7-43BD-9B4B-A140FBC29D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BCC713F-E795-468B-84D1-96D28853BC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8BED72D-E467-45BC-BFB1-CCFF9EA27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F678A64-D520-44CA-BBE5-D3B10BFA2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05958E8-D21F-45DB-A83E-F6AF06A71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0234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D46C5D-D1B7-4769-8930-34295CE65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C62DE22-7C40-47E9-89ED-5F1A98F483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0ED47B2-A022-4BAC-8B87-3EE98731F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B6D2A4-8C18-4017-9D90-B15FF6B8C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7BFE06C-59EE-4F91-B37E-98A770D1F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79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E5DD3B-A941-49EB-8810-9207B4C4A9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C002B51-5717-4222-B163-A88719B16E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625B15D-1E45-49DE-BE0E-3A1EF04B9F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9C3342A-C14C-4DF6-98EC-05FFD1D0B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BC32D4C-3B15-4F5B-BB79-C76F56DB7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9FF6371-E0D8-461B-8F89-BA3AFE438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8757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32D3711-1F0A-4DC3-8558-54C121878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C725A8B-42D6-477E-8905-18AFDA9B97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A6658F6-1C44-40E7-B0AA-95F24FCE1D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0BC473B-BB8B-4E83-AEF4-2A18D4E384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47D91F7-78F0-445F-A896-C2FB48C0AD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9AB5426-8B84-4F47-B52B-6E7FAA37F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4A07A57-5998-4220-BA96-CD30A8D70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54707C5-2B20-4DD7-A200-E46466F0A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9630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3012468-9F1E-42D5-8F24-DEF61E6C8B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851C634-7511-4481-902E-DAFD9B6DB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089276E-9EFA-4DA5-A0F3-8FC493917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1CE59E9-B3A7-47E5-B704-C7EB892E3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5528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A81B555-E3FA-46B6-8B95-60548D80E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C8CBB8F-C113-4ED3-B3D2-7B297F861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582E743-D8DB-4B59-8DAF-08449AE06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2516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ECF1FE-F3CB-4EDB-AD02-BCE4A423A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E410113-3134-45EE-BF5B-A5457E944E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0A53CAE-46CD-4777-BE55-5EAE10CF5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92C181-0452-47E2-A52E-DD115CAA0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44F9663-1351-48C8-AC3F-863EDCC46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57A5A16-7908-41F2-83B7-D8CF0F877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7186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825C61-4795-448B-B2D2-AD241A3ED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13ACCD4-4914-451E-814B-AA7A4110E6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140B1DD-CD29-4FD9-8D77-9D4A4F67E2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FDA2041-2363-4421-BB6B-5D992322B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4DE0782-1E90-4AEE-9F95-4B3439AE9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4FBD71E-837A-43B8-A998-FED86CC53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151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2BB3EEB-BF70-4908-BFAD-030B9B555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EF61320-D076-4AE0-8C96-C8E28D34C5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282A811-E31C-4A96-8D9C-F91F82F84A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6E849-8B16-413C-A8EB-D54B5ED149FE}" type="datetimeFigureOut">
              <a:rPr lang="ko-KR" altLang="en-US" smtClean="0"/>
              <a:t>2018-11-16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6E00D15-CBD6-454B-9A6E-A2AC695C4E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7522EFA-35CA-4A34-A52A-27F63873D3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317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>
            <a:extLst>
              <a:ext uri="{FF2B5EF4-FFF2-40B4-BE49-F238E27FC236}">
                <a16:creationId xmlns:a16="http://schemas.microsoft.com/office/drawing/2014/main" id="{10DCF636-80AA-41FB-BF9B-045C0B8D67F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5593" y="2476496"/>
            <a:ext cx="6400813" cy="3657607"/>
          </a:xfrm>
          <a:prstGeom prst="rect">
            <a:avLst/>
          </a:prstGeom>
        </p:spPr>
      </p:pic>
      <p:sp>
        <p:nvSpPr>
          <p:cNvPr id="6" name="직사각형 5">
            <a:extLst>
              <a:ext uri="{FF2B5EF4-FFF2-40B4-BE49-F238E27FC236}">
                <a16:creationId xmlns:a16="http://schemas.microsoft.com/office/drawing/2014/main" id="{F0A3E579-A027-4078-8D78-D0BFB76FFE50}"/>
              </a:ext>
            </a:extLst>
          </p:cNvPr>
          <p:cNvSpPr/>
          <p:nvPr/>
        </p:nvSpPr>
        <p:spPr>
          <a:xfrm>
            <a:off x="619461" y="1163040"/>
            <a:ext cx="1114391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1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Identification of soft-thresholding power for co-expression network construction. </a:t>
            </a: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A)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 analysis of scale free topology for picking an appropriate soft-thresholding power. </a:t>
            </a: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(B)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of the mean connectivity for picking an appropriate soft-thresholding power.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4" name="직사각형 3">
            <a:extLst>
              <a:ext uri="{FF2B5EF4-FFF2-40B4-BE49-F238E27FC236}">
                <a16:creationId xmlns:a16="http://schemas.microsoft.com/office/drawing/2014/main" id="{22C189B0-9264-467A-AE78-A05B229FBFF9}"/>
              </a:ext>
            </a:extLst>
          </p:cNvPr>
          <p:cNvSpPr/>
          <p:nvPr/>
        </p:nvSpPr>
        <p:spPr>
          <a:xfrm>
            <a:off x="3055108" y="2291830"/>
            <a:ext cx="508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sp>
        <p:nvSpPr>
          <p:cNvPr id="7" name="직사각형 6">
            <a:extLst>
              <a:ext uri="{FF2B5EF4-FFF2-40B4-BE49-F238E27FC236}">
                <a16:creationId xmlns:a16="http://schemas.microsoft.com/office/drawing/2014/main" id="{537BEDB9-6923-4CD6-BAAA-168F20258996}"/>
              </a:ext>
            </a:extLst>
          </p:cNvPr>
          <p:cNvSpPr/>
          <p:nvPr/>
        </p:nvSpPr>
        <p:spPr>
          <a:xfrm>
            <a:off x="6239325" y="2291830"/>
            <a:ext cx="5080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3582025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46</Words>
  <Application>Microsoft Office PowerPoint</Application>
  <PresentationFormat>와이드스크린</PresentationFormat>
  <Paragraphs>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 Junghyun</dc:creator>
  <cp:lastModifiedBy>Jung Junghyun</cp:lastModifiedBy>
  <cp:revision>9</cp:revision>
  <dcterms:created xsi:type="dcterms:W3CDTF">2018-11-15T16:59:57Z</dcterms:created>
  <dcterms:modified xsi:type="dcterms:W3CDTF">2018-11-16T05:30:40Z</dcterms:modified>
</cp:coreProperties>
</file>